
<file path=[Content_Types].xml><?xml version="1.0" encoding="utf-8"?>
<Types xmlns="http://schemas.openxmlformats.org/package/2006/content-types">
  <Override PartName="/ppt/slideLayouts/slideLayout8.xml" ContentType="application/vnd.openxmlformats-officedocument.presentationml.slideLayout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Layouts/slideLayout4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Default Extension="emf" ContentType="image/x-emf"/>
  <Default Extension="jpeg" ContentType="image/jpeg"/>
  <Default Extension="rels" ContentType="application/vnd.openxmlformats-package.relationships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theme/themeOverride3.xml" ContentType="application/vnd.openxmlformats-officedocument.themeOverride+xml"/>
  <Override PartName="/ppt/theme/themeOverride4.xml" ContentType="application/vnd.openxmlformats-officedocument.themeOverride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ppt/theme/themeOverride1.xml" ContentType="application/vnd.openxmlformats-officedocument.themeOverride+xml"/>
  <Override PartName="/ppt/theme/themeOverride2.xml" ContentType="application/vnd.openxmlformats-officedocument.themeOverride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ppt/slideLayouts/slideLayout7.xml" ContentType="application/vnd.openxmlformats-officedocument.presentationml.slideLayout+xml"/>
  <Override PartName="/customXml/itemProps2.xml" ContentType="application/vnd.openxmlformats-officedocument.customXmlProperties+xml"/>
  <Override PartName="/ppt/presProps.xml" ContentType="application/vnd.openxmlformats-officedocument.presentationml.presProps+xml"/>
  <Override PartName="/ppt/slideLayouts/slideLayout5.xml" ContentType="application/vnd.openxmlformats-officedocument.presentationml.slideLayout+xml"/>
  <Override PartName="/ppt/theme/theme2.xml" ContentType="application/vnd.openxmlformats-officedocument.them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4"/>
  </p:notesMasterIdLst>
  <p:sldIdLst>
    <p:sldId id="256" r:id="rId2"/>
    <p:sldId id="257" r:id="rId3"/>
  </p:sldIdLst>
  <p:sldSz cx="6858000" cy="9144000" type="screen4x3"/>
  <p:notesSz cx="6954838" cy="9309100"/>
  <p:defaultTextStyle>
    <a:defPPr>
      <a:defRPr lang="en-US"/>
    </a:defPPr>
    <a:lvl1pPr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632B3"/>
    <a:srgbClr val="41DAEF"/>
    <a:srgbClr val="1E14A0"/>
    <a:srgbClr val="B5FC98"/>
    <a:srgbClr val="78F73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0515" autoAdjust="0"/>
    <p:restoredTop sz="94434" autoAdjust="0"/>
  </p:normalViewPr>
  <p:slideViewPr>
    <p:cSldViewPr snapToGrid="0">
      <p:cViewPr varScale="1">
        <p:scale>
          <a:sx n="88" d="100"/>
          <a:sy n="88" d="100"/>
        </p:scale>
        <p:origin x="3198" y="9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11" Type="http://schemas.openxmlformats.org/officeDocument/2006/relationships/customXml" Target="../customXml/item3.xml"/><Relationship Id="rId5" Type="http://schemas.openxmlformats.org/officeDocument/2006/relationships/presProps" Target="presProps.xml"/><Relationship Id="rId10" Type="http://schemas.openxmlformats.org/officeDocument/2006/relationships/customXml" Target="../customXml/item2.xml"/><Relationship Id="rId4" Type="http://schemas.openxmlformats.org/officeDocument/2006/relationships/notesMaster" Target="notesMasters/notesMaster1.xml"/><Relationship Id="rId9" Type="http://schemas.openxmlformats.org/officeDocument/2006/relationships/customXml" Target="../customXml/item1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Dell\AppData\Local\Temp\Go%20biological%20PD,%20unique%20up%20down.xlsx" TargetMode="External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Dell\AppData\Local\Temp\Go%20biological%20PD,%20unique%20up%20down.xlsx" TargetMode="External"/><Relationship Id="rId1" Type="http://schemas.openxmlformats.org/officeDocument/2006/relationships/themeOverride" Target="../theme/themeOverride2.xm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oleObject" Target="Book1" TargetMode="External"/><Relationship Id="rId1" Type="http://schemas.openxmlformats.org/officeDocument/2006/relationships/themeOverride" Target="../theme/themeOverride3.xml"/></Relationships>
</file>

<file path=ppt/charts/_rels/chart4.xml.rels><?xml version="1.0" encoding="UTF-8" standalone="yes"?>
<Relationships xmlns="http://schemas.openxmlformats.org/package/2006/relationships"><Relationship Id="rId2" Type="http://schemas.openxmlformats.org/officeDocument/2006/relationships/oleObject" Target="Book1" TargetMode="External"/><Relationship Id="rId1" Type="http://schemas.openxmlformats.org/officeDocument/2006/relationships/themeOverride" Target="../theme/themeOverrid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9.4669940386044343E-2"/>
          <c:y val="5.9587548834623819E-2"/>
          <c:w val="0.80622624595773129"/>
          <c:h val="0.80877910184283319"/>
        </c:manualLayout>
      </c:layout>
      <c:doughnutChart>
        <c:varyColors val="1"/>
        <c:ser>
          <c:idx val="0"/>
          <c:order val="0"/>
          <c:tx>
            <c:strRef>
              <c:f>'[Go biological PD, unique up down.xlsx]Sheet3'!$C$1</c:f>
              <c:strCache>
                <c:ptCount val="1"/>
                <c:pt idx="0">
                  <c:v> PD Up</c:v>
                </c:pt>
              </c:strCache>
            </c:strRef>
          </c:tx>
          <c:explosion val="25"/>
          <c:dLbls>
            <c:dLbl>
              <c:idx val="0"/>
              <c:layout>
                <c:manualLayout>
                  <c:x val="8.0587983464445678E-2"/>
                  <c:y val="-3.260990973217516E-2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18.6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1"/>
              <c:layout>
                <c:manualLayout>
                  <c:x val="7.5215451233482694E-2"/>
                  <c:y val="0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2"/>
              <c:layout>
                <c:manualLayout>
                  <c:x val="8.5960515695408732E-2"/>
                  <c:y val="1.630495486608758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3"/>
              <c:layout>
                <c:manualLayout>
                  <c:x val="6.4470386771556545E-2"/>
                  <c:y val="4.3479879642900066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4"/>
              <c:layout>
                <c:manualLayout>
                  <c:x val="3.2235193385778391E-2"/>
                  <c:y val="5.9784834508987764E-2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6.4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5"/>
              <c:layout>
                <c:manualLayout>
                  <c:x val="-2.1490128923852186E-2"/>
                  <c:y val="6.5219819464350057E-2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2.2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6"/>
              <c:layout>
                <c:manualLayout>
                  <c:x val="-6.9842919002519724E-2"/>
                  <c:y val="4.3479879642900066E-2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16.9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7"/>
              <c:layout>
                <c:manualLayout>
                  <c:x val="-4.2980257847704484E-2"/>
                  <c:y val="3.260990973217516E-2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0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8"/>
              <c:layout>
                <c:manualLayout>
                  <c:x val="-7.5215451233482694E-2"/>
                  <c:y val="0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9"/>
              <c:layout>
                <c:manualLayout>
                  <c:x val="-6.4470386771556545E-2"/>
                  <c:y val="-5.4349849553624614E-3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4.7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10"/>
              <c:layout>
                <c:manualLayout>
                  <c:x val="-6.4470386771556545E-2"/>
                  <c:y val="-3.8044894687537585E-2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1.8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11"/>
              <c:layout>
                <c:manualLayout>
                  <c:x val="-3.2235193385778391E-2"/>
                  <c:y val="-6.5219819464350057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12"/>
              <c:layout>
                <c:manualLayout>
                  <c:x val="5.3725322309630483E-3"/>
                  <c:y val="-6.5219819464350057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spPr>
              <a:noFill/>
              <a:ln>
                <a:noFill/>
              </a:ln>
              <a:effectLst/>
            </c:spPr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extLst>
              <c:ext xmlns:c15="http://schemas.microsoft.com/office/drawing/2012/chart" uri="{CE6537A1-D6FC-4f65-9D91-7224C49458BB}"/>
            </c:extLst>
          </c:dLbls>
          <c:cat>
            <c:strRef>
              <c:f>'[Go biological PD, unique up down.xlsx]Sheet3'!$B$2:$B$14</c:f>
              <c:strCache>
                <c:ptCount val="13"/>
                <c:pt idx="0">
                  <c:v>cellular process</c:v>
                </c:pt>
                <c:pt idx="1">
                  <c:v>metabolic process</c:v>
                </c:pt>
                <c:pt idx="2">
                  <c:v>reproductive process</c:v>
                </c:pt>
                <c:pt idx="3">
                  <c:v>cellular component organization/biogenesis</c:v>
                </c:pt>
                <c:pt idx="4">
                  <c:v>protein sorting</c:v>
                </c:pt>
                <c:pt idx="5">
                  <c:v>immune system process</c:v>
                </c:pt>
                <c:pt idx="6">
                  <c:v>regulation of cellular growth</c:v>
                </c:pt>
                <c:pt idx="7">
                  <c:v>regulation of circadian rythm </c:v>
                </c:pt>
                <c:pt idx="8">
                  <c:v>response to stress</c:v>
                </c:pt>
                <c:pt idx="9">
                  <c:v>signaling</c:v>
                </c:pt>
                <c:pt idx="10">
                  <c:v>tissue/organ developmental process</c:v>
                </c:pt>
                <c:pt idx="11">
                  <c:v>unknown biologicalprocess</c:v>
                </c:pt>
                <c:pt idx="12">
                  <c:v>others</c:v>
                </c:pt>
              </c:strCache>
            </c:strRef>
          </c:cat>
          <c:val>
            <c:numRef>
              <c:f>'[Go biological PD, unique up down.xlsx]Sheet3'!$C$2:$C$14</c:f>
              <c:numCache>
                <c:formatCode>0.00</c:formatCode>
                <c:ptCount val="13"/>
                <c:pt idx="0">
                  <c:v>18.610000000000031</c:v>
                </c:pt>
                <c:pt idx="1">
                  <c:v>18.09</c:v>
                </c:pt>
                <c:pt idx="2">
                  <c:v>0.19</c:v>
                </c:pt>
                <c:pt idx="3">
                  <c:v>2.4</c:v>
                </c:pt>
                <c:pt idx="4">
                  <c:v>6.42</c:v>
                </c:pt>
                <c:pt idx="5">
                  <c:v>2.27</c:v>
                </c:pt>
                <c:pt idx="6">
                  <c:v>16.93</c:v>
                </c:pt>
                <c:pt idx="7">
                  <c:v>0</c:v>
                </c:pt>
                <c:pt idx="8">
                  <c:v>14.07</c:v>
                </c:pt>
                <c:pt idx="9">
                  <c:v>4.7300000000000004</c:v>
                </c:pt>
                <c:pt idx="10">
                  <c:v>1.8800000000000001</c:v>
                </c:pt>
                <c:pt idx="11">
                  <c:v>10.050000000000002</c:v>
                </c:pt>
                <c:pt idx="12">
                  <c:v>4.3499999999999996</c:v>
                </c:pt>
              </c:numCache>
            </c:numRef>
          </c:val>
        </c:ser>
        <c:ser>
          <c:idx val="1"/>
          <c:order val="1"/>
          <c:tx>
            <c:strRef>
              <c:f>'[Go biological PD, unique up down.xlsx]Sheet3'!$D$1</c:f>
              <c:strCache>
                <c:ptCount val="1"/>
                <c:pt idx="0">
                  <c:v>PD down</c:v>
                </c:pt>
              </c:strCache>
            </c:strRef>
          </c:tx>
          <c:explosion val="25"/>
          <c:dLbls>
            <c:dLbl>
              <c:idx val="0"/>
              <c:layout>
                <c:manualLayout>
                  <c:x val="0.1128231768502241"/>
                  <c:y val="-4.8914864598262546E-2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16.8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1"/>
              <c:layout>
                <c:manualLayout>
                  <c:x val="8.0587983464445734E-2"/>
                  <c:y val="-8.1524774330437907E-2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17.3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2"/>
              <c:layout>
                <c:manualLayout>
                  <c:x val="7.5215451233482694E-2"/>
                  <c:y val="3.260990973217516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3"/>
              <c:layout>
                <c:manualLayout>
                  <c:x val="8.0587983464445581E-2"/>
                  <c:y val="6.521981946434996E-2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7.8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4"/>
              <c:layout>
                <c:manualLayout>
                  <c:x val="2.1490128923852186E-2"/>
                  <c:y val="7.0654376468141364E-2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5.3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5"/>
              <c:layout>
                <c:manualLayout>
                  <c:x val="-2.6862661154815226E-2"/>
                  <c:y val="7.0654804419712641E-2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1.3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6"/>
              <c:layout>
                <c:manualLayout>
                  <c:x val="-5.3725322309630452E-2"/>
                  <c:y val="7.0654804419712641E-2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16.6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7"/>
              <c:layout>
                <c:manualLayout>
                  <c:x val="-5.3725322309630452E-2"/>
                  <c:y val="5.9784834508987764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8"/>
              <c:layout>
                <c:manualLayout>
                  <c:x val="-8.0587983464445678E-2"/>
                  <c:y val="2.1739939821450102E-2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8.2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9"/>
              <c:layout>
                <c:manualLayout>
                  <c:x val="-8.0587983464445678E-2"/>
                  <c:y val="-5.4349849553624614E-3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10"/>
              <c:layout>
                <c:manualLayout>
                  <c:x val="-6.4470386771556545E-2"/>
                  <c:y val="-5.4349849553625089E-2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12.1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11"/>
              <c:layout>
                <c:manualLayout>
                  <c:x val="-0.10207811238829786"/>
                  <c:y val="-4.8914864598262608E-2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8.8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12"/>
              <c:layout>
                <c:manualLayout>
                  <c:x val="1.6117596692889105E-2"/>
                  <c:y val="-6.5219819464350057E-2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1.3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spPr>
              <a:noFill/>
              <a:ln>
                <a:noFill/>
              </a:ln>
              <a:effectLst/>
            </c:spPr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extLst>
              <c:ext xmlns:c15="http://schemas.microsoft.com/office/drawing/2012/chart" uri="{CE6537A1-D6FC-4f65-9D91-7224C49458BB}"/>
            </c:extLst>
          </c:dLbls>
          <c:cat>
            <c:strRef>
              <c:f>'[Go biological PD, unique up down.xlsx]Sheet3'!$B$2:$B$14</c:f>
              <c:strCache>
                <c:ptCount val="13"/>
                <c:pt idx="0">
                  <c:v>cellular process</c:v>
                </c:pt>
                <c:pt idx="1">
                  <c:v>metabolic process</c:v>
                </c:pt>
                <c:pt idx="2">
                  <c:v>reproductive process</c:v>
                </c:pt>
                <c:pt idx="3">
                  <c:v>cellular component organization/biogenesis</c:v>
                </c:pt>
                <c:pt idx="4">
                  <c:v>protein sorting</c:v>
                </c:pt>
                <c:pt idx="5">
                  <c:v>immune system process</c:v>
                </c:pt>
                <c:pt idx="6">
                  <c:v>regulation of cellular growth</c:v>
                </c:pt>
                <c:pt idx="7">
                  <c:v>regulation of circadian rythm </c:v>
                </c:pt>
                <c:pt idx="8">
                  <c:v>response to stress</c:v>
                </c:pt>
                <c:pt idx="9">
                  <c:v>signaling</c:v>
                </c:pt>
                <c:pt idx="10">
                  <c:v>tissue/organ developmental process</c:v>
                </c:pt>
                <c:pt idx="11">
                  <c:v>unknown biologicalprocess</c:v>
                </c:pt>
                <c:pt idx="12">
                  <c:v>others</c:v>
                </c:pt>
              </c:strCache>
            </c:strRef>
          </c:cat>
          <c:val>
            <c:numRef>
              <c:f>'[Go biological PD, unique up down.xlsx]Sheet3'!$D$2:$D$14</c:f>
              <c:numCache>
                <c:formatCode>0.00</c:formatCode>
                <c:ptCount val="13"/>
                <c:pt idx="0">
                  <c:v>16.86</c:v>
                </c:pt>
                <c:pt idx="1">
                  <c:v>17.34</c:v>
                </c:pt>
                <c:pt idx="2">
                  <c:v>3.03</c:v>
                </c:pt>
                <c:pt idx="3">
                  <c:v>7.8599999999999985</c:v>
                </c:pt>
                <c:pt idx="4">
                  <c:v>5.35</c:v>
                </c:pt>
                <c:pt idx="5">
                  <c:v>1.37</c:v>
                </c:pt>
                <c:pt idx="6">
                  <c:v>16.670000000000005</c:v>
                </c:pt>
                <c:pt idx="7">
                  <c:v>0.62000000000000122</c:v>
                </c:pt>
                <c:pt idx="8">
                  <c:v>8.2000000000000011</c:v>
                </c:pt>
                <c:pt idx="9">
                  <c:v>0.43000000000000038</c:v>
                </c:pt>
                <c:pt idx="10">
                  <c:v>12.129999999999999</c:v>
                </c:pt>
                <c:pt idx="11">
                  <c:v>8.81</c:v>
                </c:pt>
                <c:pt idx="12">
                  <c:v>1.3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  <c:holeSize val="50"/>
      </c:doughnutChart>
    </c:plotArea>
    <c:plotVisOnly val="1"/>
    <c:dispBlanksAs val="zero"/>
    <c:showDLblsOverMax val="0"/>
  </c:chart>
  <c:txPr>
    <a:bodyPr/>
    <a:lstStyle/>
    <a:p>
      <a:pPr>
        <a:defRPr sz="800" b="1">
          <a:latin typeface="Arial" pitchFamily="34" charset="0"/>
          <a:cs typeface="Arial" pitchFamily="34" charset="0"/>
        </a:defRPr>
      </a:pPr>
      <a:endParaRPr lang="en-US"/>
    </a:p>
  </c:txPr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7.4752436802249037E-2"/>
          <c:y val="7.5541107537614116E-2"/>
          <c:w val="0.86479393725873732"/>
          <c:h val="0.84389578943477328"/>
        </c:manualLayout>
      </c:layout>
      <c:doughnutChart>
        <c:varyColors val="1"/>
        <c:ser>
          <c:idx val="0"/>
          <c:order val="0"/>
          <c:tx>
            <c:strRef>
              <c:f>'[Go biological PD, unique up down.xlsx]Sheet3'!$I$1</c:f>
              <c:strCache>
                <c:ptCount val="1"/>
                <c:pt idx="0">
                  <c:v> DP Up </c:v>
                </c:pt>
              </c:strCache>
            </c:strRef>
          </c:tx>
          <c:explosion val="25"/>
          <c:dLbls>
            <c:dLbl>
              <c:idx val="0"/>
              <c:layout>
                <c:manualLayout>
                  <c:x val="7.2166471570956264E-2"/>
                  <c:y val="-4.6948356807511762E-2"/>
                </c:manualLayout>
              </c:layout>
              <c:tx>
                <c:rich>
                  <a:bodyPr/>
                  <a:lstStyle/>
                  <a:p>
                    <a:r>
                      <a:rPr lang="en-US" sz="800" b="1" dirty="0" smtClean="0">
                        <a:latin typeface="Arial" pitchFamily="34" charset="0"/>
                        <a:cs typeface="Arial" pitchFamily="34" charset="0"/>
                      </a:rPr>
                      <a:t>17.8</a:t>
                    </a:r>
                    <a:endParaRPr lang="en-US" sz="800" b="1" dirty="0">
                      <a:latin typeface="Arial" pitchFamily="34" charset="0"/>
                      <a:cs typeface="Arial" pitchFamily="34" charset="0"/>
                    </a:endParaRP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1"/>
              <c:layout>
                <c:manualLayout>
                  <c:x val="9.0208089463695157E-2"/>
                  <c:y val="-1.7605633802816902E-2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17.3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2"/>
              <c:layout>
                <c:manualLayout>
                  <c:x val="7.818034420186909E-2"/>
                  <c:y val="0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3"/>
              <c:layout>
                <c:manualLayout>
                  <c:x val="7.2166471570956264E-2"/>
                  <c:y val="4.6948356807511735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4"/>
              <c:layout>
                <c:manualLayout>
                  <c:x val="4.8110981047304192E-2"/>
                  <c:y val="5.8685446009389665E-2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7.2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5"/>
              <c:layout>
                <c:manualLayout>
                  <c:x val="0"/>
                  <c:y val="6.4553990610328835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6"/>
              <c:layout>
                <c:manualLayout>
                  <c:x val="-3.6083235785478202E-2"/>
                  <c:y val="5.8685446009389665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8"/>
              <c:layout>
                <c:manualLayout>
                  <c:x val="-9.0208089463695157E-2"/>
                  <c:y val="2.9342723004694829E-2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14.3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9"/>
              <c:layout>
                <c:manualLayout>
                  <c:x val="-8.4194216832782165E-2"/>
                  <c:y val="5.8685446009389668E-3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5.2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10"/>
              <c:layout>
                <c:manualLayout>
                  <c:x val="-6.6152598940043134E-2"/>
                  <c:y val="-1.1737089201877967E-2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0.5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11"/>
              <c:layout>
                <c:manualLayout>
                  <c:x val="-9.0208089463695143E-2"/>
                  <c:y val="-4.1079812206572641E-2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7.4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12"/>
              <c:layout>
                <c:manualLayout>
                  <c:x val="0"/>
                  <c:y val="-5.8685446009389665E-2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6.4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/>
              <a:lstStyle/>
              <a:p>
                <a:pPr>
                  <a:defRPr sz="800" b="1">
                    <a:latin typeface="Arial" pitchFamily="34" charset="0"/>
                    <a:cs typeface="Arial" pitchFamily="34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extLst>
              <c:ext xmlns:c15="http://schemas.microsoft.com/office/drawing/2012/chart" uri="{CE6537A1-D6FC-4f65-9D91-7224C49458BB}">
                <c15:layout/>
              </c:ext>
            </c:extLst>
          </c:dLbls>
          <c:cat>
            <c:strRef>
              <c:f>'[Go biological PD, unique up down.xlsx]Sheet3'!$H$2:$H$14</c:f>
              <c:strCache>
                <c:ptCount val="13"/>
                <c:pt idx="0">
                  <c:v>cellular process</c:v>
                </c:pt>
                <c:pt idx="1">
                  <c:v>metabolic process</c:v>
                </c:pt>
                <c:pt idx="2">
                  <c:v>Reproductive process</c:v>
                </c:pt>
                <c:pt idx="3">
                  <c:v>cellular component organization or biogenesis</c:v>
                </c:pt>
                <c:pt idx="4">
                  <c:v>protein sorting</c:v>
                </c:pt>
                <c:pt idx="5">
                  <c:v>immune system process</c:v>
                </c:pt>
                <c:pt idx="6">
                  <c:v>regulation of cellular growth</c:v>
                </c:pt>
                <c:pt idx="7">
                  <c:v>regulation of circadian rythm </c:v>
                </c:pt>
                <c:pt idx="8">
                  <c:v>response to stress</c:v>
                </c:pt>
                <c:pt idx="9">
                  <c:v>signaling</c:v>
                </c:pt>
                <c:pt idx="10">
                  <c:v>tissue/organ developmental process</c:v>
                </c:pt>
                <c:pt idx="11">
                  <c:v>unknown biologicalprocess</c:v>
                </c:pt>
                <c:pt idx="12">
                  <c:v>others</c:v>
                </c:pt>
              </c:strCache>
            </c:strRef>
          </c:cat>
          <c:val>
            <c:numRef>
              <c:f>'[Go biological PD, unique up down.xlsx]Sheet3'!$I$2:$I$14</c:f>
              <c:numCache>
                <c:formatCode>General</c:formatCode>
                <c:ptCount val="13"/>
                <c:pt idx="0">
                  <c:v>17.809999999999999</c:v>
                </c:pt>
                <c:pt idx="1">
                  <c:v>17.36</c:v>
                </c:pt>
                <c:pt idx="2">
                  <c:v>0</c:v>
                </c:pt>
                <c:pt idx="3">
                  <c:v>2.8</c:v>
                </c:pt>
                <c:pt idx="4">
                  <c:v>7.23</c:v>
                </c:pt>
                <c:pt idx="5">
                  <c:v>3.8</c:v>
                </c:pt>
                <c:pt idx="6">
                  <c:v>17</c:v>
                </c:pt>
                <c:pt idx="7">
                  <c:v>0</c:v>
                </c:pt>
                <c:pt idx="8">
                  <c:v>14.38</c:v>
                </c:pt>
                <c:pt idx="9">
                  <c:v>5.24</c:v>
                </c:pt>
                <c:pt idx="10">
                  <c:v>0.54</c:v>
                </c:pt>
                <c:pt idx="11">
                  <c:v>7.41</c:v>
                </c:pt>
                <c:pt idx="12">
                  <c:v>6.42</c:v>
                </c:pt>
              </c:numCache>
            </c:numRef>
          </c:val>
        </c:ser>
        <c:ser>
          <c:idx val="1"/>
          <c:order val="1"/>
          <c:tx>
            <c:strRef>
              <c:f>'[Go biological PD, unique up down.xlsx]Sheet3'!$J$1</c:f>
              <c:strCache>
                <c:ptCount val="1"/>
                <c:pt idx="0">
                  <c:v>DP Down</c:v>
                </c:pt>
              </c:strCache>
            </c:strRef>
          </c:tx>
          <c:explosion val="25"/>
          <c:dLbls>
            <c:dLbl>
              <c:idx val="0"/>
              <c:layout>
                <c:manualLayout>
                  <c:x val="0.05"/>
                  <c:y val="-3.2407407407407531E-2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18.2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1"/>
              <c:layout>
                <c:manualLayout>
                  <c:x val="6.1111111111111123E-2"/>
                  <c:y val="-2.7777777777777936E-2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17.9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2"/>
              <c:layout>
                <c:manualLayout>
                  <c:x val="9.6221962094608288E-2"/>
                  <c:y val="3.5211267605633811E-2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1.4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3"/>
              <c:layout>
                <c:manualLayout>
                  <c:x val="4.2097108416391082E-2"/>
                  <c:y val="5.8685446009389665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4"/>
              <c:layout>
                <c:manualLayout>
                  <c:x val="1.8041617892739031E-2"/>
                  <c:y val="8.2159624413145449E-2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3.7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6"/>
              <c:layout>
                <c:manualLayout>
                  <c:x val="-6.0138726309130114E-2"/>
                  <c:y val="7.0422535211267623E-2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18.8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8"/>
              <c:layout>
                <c:manualLayout>
                  <c:x val="-6.6152598940043134E-2"/>
                  <c:y val="3.5211267605633881E-2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8.7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10"/>
              <c:layout>
                <c:manualLayout>
                  <c:x val="-5.5555555555555455E-2"/>
                  <c:y val="-5.5555555555555455E-2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13.9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11"/>
              <c:layout>
                <c:manualLayout>
                  <c:x val="-7.405539581699655E-2"/>
                  <c:y val="-5.8033436841521853E-2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9.2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12"/>
              <c:layout>
                <c:manualLayout>
                  <c:x val="5.5555555555555558E-3"/>
                  <c:y val="-1.3888888888888944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/>
              <a:lstStyle/>
              <a:p>
                <a:pPr>
                  <a:defRPr sz="800" b="1">
                    <a:latin typeface="Arial" pitchFamily="34" charset="0"/>
                    <a:cs typeface="Arial" pitchFamily="34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extLst>
              <c:ext xmlns:c15="http://schemas.microsoft.com/office/drawing/2012/chart" uri="{CE6537A1-D6FC-4f65-9D91-7224C49458BB}">
                <c15:layout/>
              </c:ext>
            </c:extLst>
          </c:dLbls>
          <c:cat>
            <c:strRef>
              <c:f>'[Go biological PD, unique up down.xlsx]Sheet3'!$H$2:$H$14</c:f>
              <c:strCache>
                <c:ptCount val="13"/>
                <c:pt idx="0">
                  <c:v>cellular process</c:v>
                </c:pt>
                <c:pt idx="1">
                  <c:v>metabolic process</c:v>
                </c:pt>
                <c:pt idx="2">
                  <c:v>Reproductive process</c:v>
                </c:pt>
                <c:pt idx="3">
                  <c:v>cellular component organization or biogenesis</c:v>
                </c:pt>
                <c:pt idx="4">
                  <c:v>protein sorting</c:v>
                </c:pt>
                <c:pt idx="5">
                  <c:v>immune system process</c:v>
                </c:pt>
                <c:pt idx="6">
                  <c:v>regulation of cellular growth</c:v>
                </c:pt>
                <c:pt idx="7">
                  <c:v>regulation of circadian rythm </c:v>
                </c:pt>
                <c:pt idx="8">
                  <c:v>response to stress</c:v>
                </c:pt>
                <c:pt idx="9">
                  <c:v>signaling</c:v>
                </c:pt>
                <c:pt idx="10">
                  <c:v>tissue/organ developmental process</c:v>
                </c:pt>
                <c:pt idx="11">
                  <c:v>unknown biologicalprocess</c:v>
                </c:pt>
                <c:pt idx="12">
                  <c:v>others</c:v>
                </c:pt>
              </c:strCache>
            </c:strRef>
          </c:cat>
          <c:val>
            <c:numRef>
              <c:f>'[Go biological PD, unique up down.xlsx]Sheet3'!$J$2:$J$14</c:f>
              <c:numCache>
                <c:formatCode>General</c:formatCode>
                <c:ptCount val="13"/>
                <c:pt idx="0">
                  <c:v>18.22</c:v>
                </c:pt>
                <c:pt idx="1">
                  <c:v>17.95</c:v>
                </c:pt>
                <c:pt idx="2">
                  <c:v>1.44</c:v>
                </c:pt>
                <c:pt idx="3">
                  <c:v>7.9</c:v>
                </c:pt>
                <c:pt idx="4">
                  <c:v>3.77</c:v>
                </c:pt>
                <c:pt idx="6">
                  <c:v>18.86</c:v>
                </c:pt>
                <c:pt idx="7">
                  <c:v>0</c:v>
                </c:pt>
                <c:pt idx="8">
                  <c:v>8.7100000000000009</c:v>
                </c:pt>
                <c:pt idx="9">
                  <c:v>0</c:v>
                </c:pt>
                <c:pt idx="10">
                  <c:v>13.91</c:v>
                </c:pt>
                <c:pt idx="11">
                  <c:v>9.25</c:v>
                </c:pt>
                <c:pt idx="12">
                  <c:v>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  <c:holeSize val="50"/>
      </c:doughnutChart>
    </c:plotArea>
    <c:plotVisOnly val="1"/>
    <c:dispBlanksAs val="zero"/>
    <c:showDLblsOverMax val="0"/>
  </c:chart>
  <c:externalData r:id="rId2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1186986273137198"/>
          <c:y val="5.9770705745115192E-2"/>
          <c:w val="0.80209720167598575"/>
          <c:h val="0.82994750656168148"/>
        </c:manualLayout>
      </c:layout>
      <c:doughnutChart>
        <c:varyColors val="1"/>
        <c:ser>
          <c:idx val="0"/>
          <c:order val="0"/>
          <c:tx>
            <c:strRef>
              <c:f>'DP, UP, DOWN MOL'!$B$1</c:f>
              <c:strCache>
                <c:ptCount val="1"/>
                <c:pt idx="0">
                  <c:v>DP DOWN</c:v>
                </c:pt>
              </c:strCache>
            </c:strRef>
          </c:tx>
          <c:explosion val="25"/>
          <c:dLbls>
            <c:dLbl>
              <c:idx val="0"/>
              <c:layout>
                <c:manualLayout>
                  <c:x val="8.9485490139157228E-3"/>
                  <c:y val="-6.9444444444444503E-2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5.6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1"/>
              <c:layout>
                <c:manualLayout>
                  <c:x val="4.0268470562620721E-2"/>
                  <c:y val="-5.5555555555555455E-2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6.3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2"/>
              <c:layout>
                <c:manualLayout>
                  <c:x val="6.7114117604367737E-2"/>
                  <c:y val="-3.7037037037037056E-2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1.5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3"/>
              <c:layout>
                <c:manualLayout>
                  <c:x val="7.6062666618283523E-2"/>
                  <c:y val="-2.3148148148148147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4"/>
              <c:layout>
                <c:manualLayout>
                  <c:x val="7.6062666618283523E-2"/>
                  <c:y val="9.2592592592593073E-3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7.3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5"/>
              <c:layout>
                <c:manualLayout>
                  <c:x val="6.7114117604367737E-2"/>
                  <c:y val="1.8518518518518559E-2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10.5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6"/>
              <c:layout>
                <c:manualLayout>
                  <c:x val="9.6536256169213783E-2"/>
                  <c:y val="1.968659975094823E-2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4.09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7"/>
              <c:layout>
                <c:manualLayout>
                  <c:x val="5.8165568590451876E-2"/>
                  <c:y val="5.5555555555555455E-2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0.6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8"/>
              <c:layout>
                <c:manualLayout>
                  <c:x val="-4.4743673337153895E-3"/>
                  <c:y val="7.2343137619712325E-2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0.3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9"/>
              <c:layout>
                <c:manualLayout>
                  <c:x val="-5.3691294083494191E-2"/>
                  <c:y val="5.5555191017789454E-2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9.7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10"/>
              <c:layout>
                <c:manualLayout>
                  <c:x val="-5.8165568590451862E-2"/>
                  <c:y val="3.7037037037037056E-2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14.8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11"/>
              <c:layout>
                <c:manualLayout>
                  <c:x val="-7.1588392111325588E-2"/>
                  <c:y val="-4.6296296296296412E-2"/>
                </c:manualLayout>
              </c:layout>
              <c:tx>
                <c:rich>
                  <a:bodyPr/>
                  <a:lstStyle/>
                  <a:p>
                    <a:r>
                      <a:rPr lang="en-US" smtClean="0"/>
                      <a:t>20.8</a:t>
                    </a:r>
                    <a:endParaRPr lang="en-US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12"/>
              <c:layout>
                <c:manualLayout>
                  <c:x val="-5.3691294083494191E-2"/>
                  <c:y val="-5.5555555555555455E-2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10.06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spPr>
              <a:noFill/>
              <a:ln>
                <a:noFill/>
              </a:ln>
              <a:effectLst/>
            </c:spPr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extLst>
              <c:ext xmlns:c15="http://schemas.microsoft.com/office/drawing/2012/chart" uri="{CE6537A1-D6FC-4f65-9D91-7224C49458BB}"/>
            </c:extLst>
          </c:dLbls>
          <c:cat>
            <c:strRef>
              <c:f>'DP, UP, DOWN MOL'!$A$2:$A$14</c:f>
              <c:strCache>
                <c:ptCount val="13"/>
                <c:pt idx="0">
                  <c:v>transporter activity</c:v>
                </c:pt>
                <c:pt idx="1">
                  <c:v>DNA or RNA binding</c:v>
                </c:pt>
                <c:pt idx="2">
                  <c:v>transcription factor activity</c:v>
                </c:pt>
                <c:pt idx="3">
                  <c:v>nucleotide binding</c:v>
                </c:pt>
                <c:pt idx="4">
                  <c:v>protein binding</c:v>
                </c:pt>
                <c:pt idx="5">
                  <c:v>transferase activity</c:v>
                </c:pt>
                <c:pt idx="6">
                  <c:v>kinase activity</c:v>
                </c:pt>
                <c:pt idx="7">
                  <c:v>structural molecule activity</c:v>
                </c:pt>
                <c:pt idx="8">
                  <c:v>receptor binding/activity</c:v>
                </c:pt>
                <c:pt idx="9">
                  <c:v>hydrolase activity</c:v>
                </c:pt>
                <c:pt idx="10">
                  <c:v>other enzyme actiity</c:v>
                </c:pt>
                <c:pt idx="11">
                  <c:v>other binding</c:v>
                </c:pt>
                <c:pt idx="12">
                  <c:v>unknown molecular functions</c:v>
                </c:pt>
              </c:strCache>
            </c:strRef>
          </c:cat>
          <c:val>
            <c:numRef>
              <c:f>'DP, UP, DOWN MOL'!$B$2:$B$14</c:f>
              <c:numCache>
                <c:formatCode>General</c:formatCode>
                <c:ptCount val="13"/>
                <c:pt idx="0">
                  <c:v>5.6310000000000002</c:v>
                </c:pt>
                <c:pt idx="1">
                  <c:v>6.3139999999999965</c:v>
                </c:pt>
                <c:pt idx="2">
                  <c:v>1.536</c:v>
                </c:pt>
                <c:pt idx="3">
                  <c:v>8.02</c:v>
                </c:pt>
                <c:pt idx="4">
                  <c:v>7.3380000000000001</c:v>
                </c:pt>
                <c:pt idx="5">
                  <c:v>10.58</c:v>
                </c:pt>
                <c:pt idx="6">
                  <c:v>4.069</c:v>
                </c:pt>
                <c:pt idx="7">
                  <c:v>0.68300000000000005</c:v>
                </c:pt>
                <c:pt idx="8">
                  <c:v>0.34100000000000008</c:v>
                </c:pt>
                <c:pt idx="9">
                  <c:v>9.7270000000000003</c:v>
                </c:pt>
                <c:pt idx="10">
                  <c:v>14.846</c:v>
                </c:pt>
                <c:pt idx="11">
                  <c:v>20.818999999999999</c:v>
                </c:pt>
                <c:pt idx="12">
                  <c:v>10.068</c:v>
                </c:pt>
              </c:numCache>
            </c:numRef>
          </c:val>
        </c:ser>
        <c:ser>
          <c:idx val="1"/>
          <c:order val="1"/>
          <c:tx>
            <c:strRef>
              <c:f>'DP, UP, DOWN MOL'!$C$1</c:f>
              <c:strCache>
                <c:ptCount val="1"/>
                <c:pt idx="0">
                  <c:v>DP UP</c:v>
                </c:pt>
              </c:strCache>
            </c:strRef>
          </c:tx>
          <c:explosion val="25"/>
          <c:dLbls>
            <c:dLbl>
              <c:idx val="0"/>
              <c:layout>
                <c:manualLayout>
                  <c:x val="7.6062666618283523E-2"/>
                  <c:y val="-6.0185185185185147E-2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7.3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1"/>
              <c:layout>
                <c:manualLayout>
                  <c:x val="0.10738258816698842"/>
                  <c:y val="-6.9444444444444503E-2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3.7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2"/>
              <c:layout>
                <c:manualLayout>
                  <c:x val="0.10738258816698842"/>
                  <c:y val="-4.1666666666666664E-2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2.1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3"/>
              <c:layout>
                <c:manualLayout>
                  <c:x val="8.5011215632199114E-2"/>
                  <c:y val="-4.1666666666666664E-2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6.5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4"/>
              <c:layout>
                <c:manualLayout>
                  <c:x val="7.1588392111325588E-2"/>
                  <c:y val="-2.3148148148148147E-2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7.3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5"/>
              <c:layout>
                <c:manualLayout>
                  <c:x val="9.8434039153073125E-2"/>
                  <c:y val="2.7777777777777912E-2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12.2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6"/>
              <c:layout>
                <c:manualLayout>
                  <c:x val="0.12080541168786191"/>
                  <c:y val="2.7777777777777912E-2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6.8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7"/>
              <c:layout>
                <c:manualLayout>
                  <c:x val="7.6062666618283523E-2"/>
                  <c:y val="6.9444444444444503E-2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0.3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8"/>
              <c:layout>
                <c:manualLayout>
                  <c:x val="-2.2371372534789366E-2"/>
                  <c:y val="7.8703703703703734E-2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0.5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9"/>
              <c:layout>
                <c:manualLayout>
                  <c:x val="-8.0536941125241651E-2"/>
                  <c:y val="5.5555555555555455E-2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10.4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10"/>
              <c:layout>
                <c:manualLayout>
                  <c:x val="-8.9485490139157048E-2"/>
                  <c:y val="6.4814814814814992E-2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12.08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11"/>
              <c:layout>
                <c:manualLayout>
                  <c:x val="-5.3691294083494191E-2"/>
                  <c:y val="-0.12037037037037036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22.1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12"/>
              <c:layout>
                <c:manualLayout>
                  <c:x val="-7.6062666618283523E-2"/>
                  <c:y val="-5.5555555555555455E-2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7.8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spPr>
              <a:noFill/>
              <a:ln>
                <a:noFill/>
              </a:ln>
              <a:effectLst/>
            </c:spPr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extLst>
              <c:ext xmlns:c15="http://schemas.microsoft.com/office/drawing/2012/chart" uri="{CE6537A1-D6FC-4f65-9D91-7224C49458BB}"/>
            </c:extLst>
          </c:dLbls>
          <c:cat>
            <c:strRef>
              <c:f>'DP, UP, DOWN MOL'!$A$2:$A$14</c:f>
              <c:strCache>
                <c:ptCount val="13"/>
                <c:pt idx="0">
                  <c:v>transporter activity</c:v>
                </c:pt>
                <c:pt idx="1">
                  <c:v>DNA or RNA binding</c:v>
                </c:pt>
                <c:pt idx="2">
                  <c:v>transcription factor activity</c:v>
                </c:pt>
                <c:pt idx="3">
                  <c:v>nucleotide binding</c:v>
                </c:pt>
                <c:pt idx="4">
                  <c:v>protein binding</c:v>
                </c:pt>
                <c:pt idx="5">
                  <c:v>transferase activity</c:v>
                </c:pt>
                <c:pt idx="6">
                  <c:v>kinase activity</c:v>
                </c:pt>
                <c:pt idx="7">
                  <c:v>structural molecule activity</c:v>
                </c:pt>
                <c:pt idx="8">
                  <c:v>receptor binding/activity</c:v>
                </c:pt>
                <c:pt idx="9">
                  <c:v>hydrolase activity</c:v>
                </c:pt>
                <c:pt idx="10">
                  <c:v>other enzyme actiity</c:v>
                </c:pt>
                <c:pt idx="11">
                  <c:v>other binding</c:v>
                </c:pt>
                <c:pt idx="12">
                  <c:v>unknown molecular functions</c:v>
                </c:pt>
              </c:strCache>
            </c:strRef>
          </c:cat>
          <c:val>
            <c:numRef>
              <c:f>'DP, UP, DOWN MOL'!$C$2:$C$14</c:f>
              <c:numCache>
                <c:formatCode>General</c:formatCode>
                <c:ptCount val="13"/>
                <c:pt idx="0">
                  <c:v>7.383</c:v>
                </c:pt>
                <c:pt idx="1">
                  <c:v>3.7246000000000001</c:v>
                </c:pt>
                <c:pt idx="2">
                  <c:v>2.181</c:v>
                </c:pt>
                <c:pt idx="3">
                  <c:v>6.5439999999999996</c:v>
                </c:pt>
                <c:pt idx="4">
                  <c:v>7.383</c:v>
                </c:pt>
                <c:pt idx="5">
                  <c:v>12.247999999999999</c:v>
                </c:pt>
                <c:pt idx="6">
                  <c:v>6.8789999999999996</c:v>
                </c:pt>
                <c:pt idx="7">
                  <c:v>0.33600000000000074</c:v>
                </c:pt>
                <c:pt idx="8">
                  <c:v>0.503</c:v>
                </c:pt>
                <c:pt idx="9">
                  <c:v>10.403</c:v>
                </c:pt>
                <c:pt idx="10">
                  <c:v>12.081</c:v>
                </c:pt>
                <c:pt idx="11">
                  <c:v>22.148</c:v>
                </c:pt>
                <c:pt idx="12">
                  <c:v>7.885999999999997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  <c:holeSize val="50"/>
      </c:doughnutChart>
    </c:plotArea>
    <c:plotVisOnly val="1"/>
    <c:dispBlanksAs val="zero"/>
    <c:showDLblsOverMax val="0"/>
  </c:chart>
  <c:txPr>
    <a:bodyPr/>
    <a:lstStyle/>
    <a:p>
      <a:pPr>
        <a:defRPr sz="800" b="1">
          <a:latin typeface="Arial" pitchFamily="34" charset="0"/>
          <a:cs typeface="Arial" pitchFamily="34" charset="0"/>
        </a:defRPr>
      </a:pPr>
      <a:endParaRPr lang="en-US"/>
    </a:p>
  </c:txPr>
  <c:externalData r:id="rId2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1.7814579629159309E-2"/>
          <c:y val="0.10817827798699117"/>
          <c:w val="0.88639420878841768"/>
          <c:h val="0.7466907737076347"/>
        </c:manualLayout>
      </c:layout>
      <c:doughnutChart>
        <c:varyColors val="1"/>
        <c:ser>
          <c:idx val="0"/>
          <c:order val="0"/>
          <c:tx>
            <c:strRef>
              <c:f>Sheet6!$B$1</c:f>
              <c:strCache>
                <c:ptCount val="1"/>
                <c:pt idx="0">
                  <c:v>PD DOWN</c:v>
                </c:pt>
              </c:strCache>
            </c:strRef>
          </c:tx>
          <c:explosion val="25"/>
          <c:dLbls>
            <c:dLbl>
              <c:idx val="0"/>
              <c:layout>
                <c:manualLayout>
                  <c:x val="3.2258064516129122E-2"/>
                  <c:y val="-5.434782608695652E-2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7.1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1"/>
              <c:layout>
                <c:manualLayout>
                  <c:x val="5.8064516129032392E-2"/>
                  <c:y val="-5.434782608695652E-2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7.1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2"/>
              <c:layout>
                <c:manualLayout>
                  <c:x val="8.3870967741935504E-2"/>
                  <c:y val="-3.2608695652174037E-2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1.1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3"/>
              <c:layout>
                <c:manualLayout>
                  <c:x val="9.6774193548387247E-2"/>
                  <c:y val="0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6.7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4"/>
              <c:layout>
                <c:manualLayout>
                  <c:x val="6.4516129032258132E-2"/>
                  <c:y val="3.8043478260869602E-2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7.5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5"/>
              <c:layout>
                <c:manualLayout>
                  <c:x val="5.8064516129032392E-2"/>
                  <c:y val="4.3478260869565223E-2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14.8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6"/>
              <c:layout>
                <c:manualLayout>
                  <c:x val="7.7419354838709833E-2"/>
                  <c:y val="5.9782608695652183E-2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5.9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7"/>
              <c:layout>
                <c:manualLayout>
                  <c:x val="2.5806451612903236E-2"/>
                  <c:y val="7.0652173913043514E-2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2.2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8"/>
              <c:layout>
                <c:manualLayout>
                  <c:x val="-4.5161290322580733E-2"/>
                  <c:y val="6.5217391304347824E-2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0.2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9"/>
              <c:layout>
                <c:manualLayout>
                  <c:x val="-3.8709677419354958E-2"/>
                  <c:y val="4.3478260869565223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10"/>
              <c:layout>
                <c:manualLayout>
                  <c:x val="-9.0322580645161188E-2"/>
                  <c:y val="2.7173913043478361E-2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10.5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11"/>
              <c:layout>
                <c:manualLayout>
                  <c:x val="-4.5161290322580733E-2"/>
                  <c:y val="-6.5217391304347824E-2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19.8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12"/>
              <c:layout>
                <c:manualLayout>
                  <c:x val="-6.4516129032258273E-3"/>
                  <c:y val="-5.434782608695652E-2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7.06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spPr>
              <a:noFill/>
              <a:ln>
                <a:noFill/>
              </a:ln>
              <a:effectLst/>
            </c:spPr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extLst>
              <c:ext xmlns:c15="http://schemas.microsoft.com/office/drawing/2012/chart" uri="{CE6537A1-D6FC-4f65-9D91-7224C49458BB}"/>
            </c:extLst>
          </c:dLbls>
          <c:cat>
            <c:strRef>
              <c:f>Sheet6!$A$2:$A$14</c:f>
              <c:strCache>
                <c:ptCount val="13"/>
                <c:pt idx="0">
                  <c:v>transporter activity</c:v>
                </c:pt>
                <c:pt idx="1">
                  <c:v>DNA or RNA binding</c:v>
                </c:pt>
                <c:pt idx="2">
                  <c:v>transcription factor activity</c:v>
                </c:pt>
                <c:pt idx="3">
                  <c:v>nucleotide binding</c:v>
                </c:pt>
                <c:pt idx="4">
                  <c:v>protein binding</c:v>
                </c:pt>
                <c:pt idx="5">
                  <c:v>transferase activity</c:v>
                </c:pt>
                <c:pt idx="6">
                  <c:v>kinase activity</c:v>
                </c:pt>
                <c:pt idx="7">
                  <c:v>structural molecule activity</c:v>
                </c:pt>
                <c:pt idx="8">
                  <c:v>receptor binding/activity</c:v>
                </c:pt>
                <c:pt idx="9">
                  <c:v>hydrolase activity</c:v>
                </c:pt>
                <c:pt idx="10">
                  <c:v>other enzyme actiity</c:v>
                </c:pt>
                <c:pt idx="11">
                  <c:v>other binding</c:v>
                </c:pt>
                <c:pt idx="12">
                  <c:v>unknown molecular functions</c:v>
                </c:pt>
              </c:strCache>
            </c:strRef>
          </c:cat>
          <c:val>
            <c:numRef>
              <c:f>Sheet6!$B$2:$B$14</c:f>
              <c:numCache>
                <c:formatCode>General</c:formatCode>
                <c:ptCount val="13"/>
                <c:pt idx="0">
                  <c:v>7.1559999999999908</c:v>
                </c:pt>
                <c:pt idx="1">
                  <c:v>7.1569999999999965</c:v>
                </c:pt>
                <c:pt idx="2">
                  <c:v>1.145</c:v>
                </c:pt>
                <c:pt idx="3">
                  <c:v>6.7750000000000004</c:v>
                </c:pt>
                <c:pt idx="4">
                  <c:v>7.5380000000000003</c:v>
                </c:pt>
                <c:pt idx="5">
                  <c:v>14.885000000000018</c:v>
                </c:pt>
                <c:pt idx="6">
                  <c:v>5.9160000000000004</c:v>
                </c:pt>
                <c:pt idx="7">
                  <c:v>2.29</c:v>
                </c:pt>
                <c:pt idx="8">
                  <c:v>0.28600000000000031</c:v>
                </c:pt>
                <c:pt idx="9">
                  <c:v>9.3510000000000026</c:v>
                </c:pt>
                <c:pt idx="10">
                  <c:v>10.592000000000002</c:v>
                </c:pt>
                <c:pt idx="11">
                  <c:v>19.847000000000001</c:v>
                </c:pt>
                <c:pt idx="12">
                  <c:v>7.0609999999999955</c:v>
                </c:pt>
              </c:numCache>
            </c:numRef>
          </c:val>
        </c:ser>
        <c:ser>
          <c:idx val="1"/>
          <c:order val="1"/>
          <c:tx>
            <c:strRef>
              <c:f>Sheet6!$C$1</c:f>
              <c:strCache>
                <c:ptCount val="1"/>
                <c:pt idx="0">
                  <c:v>PD UP</c:v>
                </c:pt>
              </c:strCache>
            </c:strRef>
          </c:tx>
          <c:explosion val="25"/>
          <c:dLbls>
            <c:dLbl>
              <c:idx val="0"/>
              <c:layout>
                <c:manualLayout>
                  <c:x val="4.5161290322580733E-2"/>
                  <c:y val="-7.0652173913043514E-2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6.3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1"/>
              <c:layout>
                <c:manualLayout>
                  <c:x val="0.10322580645161336"/>
                  <c:y val="-5.4347826086956513E-2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9.4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2"/>
              <c:layout>
                <c:manualLayout>
                  <c:x val="5.1612903225806583E-2"/>
                  <c:y val="-6.5217391304347824E-2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4.7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3"/>
              <c:layout>
                <c:manualLayout>
                  <c:x val="7.0967741935484024E-2"/>
                  <c:y val="-3.8043478260869602E-2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5.8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4"/>
              <c:layout>
                <c:manualLayout>
                  <c:x val="7.7419354838709584E-2"/>
                  <c:y val="3.8043478260869602E-2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8.1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5"/>
              <c:layout>
                <c:manualLayout>
                  <c:x val="7.0967741935484024E-2"/>
                  <c:y val="5.9782608695652183E-2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11.4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6"/>
              <c:layout>
                <c:manualLayout>
                  <c:x val="3.2258064516129059E-2"/>
                  <c:y val="5.9782608695652092E-2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7.3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7"/>
              <c:layout>
                <c:manualLayout>
                  <c:x val="1.290322580645162E-2"/>
                  <c:y val="7.0652173913043514E-2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0.5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8"/>
              <c:layout>
                <c:manualLayout>
                  <c:x val="-8.3870967741935504E-2"/>
                  <c:y val="6.5217391304347921E-2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0.7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9"/>
              <c:layout>
                <c:manualLayout>
                  <c:x val="-5.8064516129032399E-2"/>
                  <c:y val="5.9782608695652183E-2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9.7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10"/>
              <c:layout>
                <c:manualLayout>
                  <c:x val="-5.1612903225806583E-2"/>
                  <c:y val="6.5217391304347824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11"/>
              <c:layout>
                <c:manualLayout>
                  <c:x val="0"/>
                  <c:y val="-0.1304347826086957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19.1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12"/>
              <c:layout>
                <c:manualLayout>
                  <c:x val="-7.0968249936499889E-2"/>
                  <c:y val="-5.434782608695652E-2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9.09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spPr>
              <a:noFill/>
              <a:ln>
                <a:noFill/>
              </a:ln>
              <a:effectLst/>
            </c:spPr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extLst>
              <c:ext xmlns:c15="http://schemas.microsoft.com/office/drawing/2012/chart" uri="{CE6537A1-D6FC-4f65-9D91-7224C49458BB}"/>
            </c:extLst>
          </c:dLbls>
          <c:cat>
            <c:strRef>
              <c:f>Sheet6!$A$2:$A$14</c:f>
              <c:strCache>
                <c:ptCount val="13"/>
                <c:pt idx="0">
                  <c:v>transporter activity</c:v>
                </c:pt>
                <c:pt idx="1">
                  <c:v>DNA or RNA binding</c:v>
                </c:pt>
                <c:pt idx="2">
                  <c:v>transcription factor activity</c:v>
                </c:pt>
                <c:pt idx="3">
                  <c:v>nucleotide binding</c:v>
                </c:pt>
                <c:pt idx="4">
                  <c:v>protein binding</c:v>
                </c:pt>
                <c:pt idx="5">
                  <c:v>transferase activity</c:v>
                </c:pt>
                <c:pt idx="6">
                  <c:v>kinase activity</c:v>
                </c:pt>
                <c:pt idx="7">
                  <c:v>structural molecule activity</c:v>
                </c:pt>
                <c:pt idx="8">
                  <c:v>receptor binding/activity</c:v>
                </c:pt>
                <c:pt idx="9">
                  <c:v>hydrolase activity</c:v>
                </c:pt>
                <c:pt idx="10">
                  <c:v>other enzyme actiity</c:v>
                </c:pt>
                <c:pt idx="11">
                  <c:v>other binding</c:v>
                </c:pt>
                <c:pt idx="12">
                  <c:v>unknown molecular functions</c:v>
                </c:pt>
              </c:strCache>
            </c:strRef>
          </c:cat>
          <c:val>
            <c:numRef>
              <c:f>Sheet6!$C$2:$C$14</c:f>
              <c:numCache>
                <c:formatCode>General</c:formatCode>
                <c:ptCount val="13"/>
                <c:pt idx="0">
                  <c:v>6.3739999999999997</c:v>
                </c:pt>
                <c:pt idx="1">
                  <c:v>9.4040000000000035</c:v>
                </c:pt>
                <c:pt idx="2">
                  <c:v>4.702</c:v>
                </c:pt>
                <c:pt idx="3">
                  <c:v>5.8519999999999985</c:v>
                </c:pt>
                <c:pt idx="4">
                  <c:v>8.15</c:v>
                </c:pt>
                <c:pt idx="5">
                  <c:v>11.494</c:v>
                </c:pt>
                <c:pt idx="6">
                  <c:v>7.3149999999999906</c:v>
                </c:pt>
                <c:pt idx="7">
                  <c:v>0.52200000000000002</c:v>
                </c:pt>
                <c:pt idx="8">
                  <c:v>0.73100000000000065</c:v>
                </c:pt>
                <c:pt idx="9">
                  <c:v>9.7409999999999997</c:v>
                </c:pt>
                <c:pt idx="10">
                  <c:v>9.3000000000000007</c:v>
                </c:pt>
                <c:pt idx="11">
                  <c:v>19.122</c:v>
                </c:pt>
                <c:pt idx="12">
                  <c:v>9.091000000000001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  <c:holeSize val="50"/>
      </c:doughnutChart>
    </c:plotArea>
    <c:plotVisOnly val="1"/>
    <c:dispBlanksAs val="zero"/>
    <c:showDLblsOverMax val="0"/>
  </c:chart>
  <c:txPr>
    <a:bodyPr/>
    <a:lstStyle/>
    <a:p>
      <a:pPr>
        <a:defRPr sz="800" b="1">
          <a:latin typeface="Arial" pitchFamily="34" charset="0"/>
          <a:cs typeface="Arial" pitchFamily="34" charset="0"/>
        </a:defRPr>
      </a:pPr>
      <a:endParaRPr lang="en-US"/>
    </a:p>
  </c:txPr>
  <c:externalData r:id="rId2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13075" cy="466725"/>
          </a:xfrm>
          <a:prstGeom prst="rect">
            <a:avLst/>
          </a:prstGeom>
        </p:spPr>
        <p:txBody>
          <a:bodyPr vert="horz" lIns="92930" tIns="46465" rIns="92930" bIns="46465" rtlCol="0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40175" y="0"/>
            <a:ext cx="3013075" cy="466725"/>
          </a:xfrm>
          <a:prstGeom prst="rect">
            <a:avLst/>
          </a:prstGeom>
        </p:spPr>
        <p:txBody>
          <a:bodyPr vert="horz" lIns="92930" tIns="46465" rIns="92930" bIns="46465" rtlCol="0"/>
          <a:lstStyle>
            <a:lvl1pPr algn="r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fld id="{A1F53406-0B4B-4C33-882B-69D39D5740DA}" type="datetimeFigureOut">
              <a:rPr lang="en-US"/>
              <a:pPr>
                <a:defRPr/>
              </a:pPr>
              <a:t>4/3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00288" y="1163638"/>
            <a:ext cx="2354262" cy="314166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930" tIns="46465" rIns="92930" bIns="46465" rtlCol="0" anchor="ctr"/>
          <a:lstStyle/>
          <a:p>
            <a:pPr lvl="0"/>
            <a:endParaRPr lang="en-US" noProof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95325" y="4479925"/>
            <a:ext cx="5564188" cy="3665538"/>
          </a:xfrm>
          <a:prstGeom prst="rect">
            <a:avLst/>
          </a:prstGeom>
        </p:spPr>
        <p:txBody>
          <a:bodyPr vert="horz" lIns="92930" tIns="46465" rIns="92930" bIns="46465" rtlCol="0"/>
          <a:lstStyle/>
          <a:p>
            <a:pPr lvl="0"/>
            <a:r>
              <a:rPr lang="en-US" noProof="0" smtClean="0"/>
              <a:t>Click to edit Master text styles</a:t>
            </a:r>
          </a:p>
          <a:p>
            <a:pPr lvl="1"/>
            <a:r>
              <a:rPr lang="en-US" noProof="0" smtClean="0"/>
              <a:t>Second level</a:t>
            </a:r>
          </a:p>
          <a:p>
            <a:pPr lvl="2"/>
            <a:r>
              <a:rPr lang="en-US" noProof="0" smtClean="0"/>
              <a:t>Third level</a:t>
            </a:r>
          </a:p>
          <a:p>
            <a:pPr lvl="3"/>
            <a:r>
              <a:rPr lang="en-US" noProof="0" smtClean="0"/>
              <a:t>Fourth level</a:t>
            </a:r>
          </a:p>
          <a:p>
            <a:pPr lvl="4"/>
            <a:r>
              <a:rPr lang="en-US" noProof="0" smtClean="0"/>
              <a:t>Fifth level</a:t>
            </a:r>
            <a:endParaRPr lang="en-US" noProof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42375"/>
            <a:ext cx="3013075" cy="466725"/>
          </a:xfrm>
          <a:prstGeom prst="rect">
            <a:avLst/>
          </a:prstGeom>
        </p:spPr>
        <p:txBody>
          <a:bodyPr vert="horz" lIns="92930" tIns="46465" rIns="92930" bIns="46465" rtlCol="0" anchor="b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40175" y="8842375"/>
            <a:ext cx="3013075" cy="466725"/>
          </a:xfrm>
          <a:prstGeom prst="rect">
            <a:avLst/>
          </a:prstGeom>
        </p:spPr>
        <p:txBody>
          <a:bodyPr vert="horz" wrap="square" lIns="92930" tIns="46465" rIns="92930" bIns="46465" numCol="1" anchor="b" anchorCtr="0" compatLnSpc="1">
            <a:prstTxWarp prst="textNoShape">
              <a:avLst/>
            </a:prstTxWarp>
          </a:bodyPr>
          <a:lstStyle>
            <a:lvl1pPr algn="r" eaLnBrk="1" hangingPunct="1">
              <a:defRPr sz="1200" smtClean="0">
                <a:latin typeface="Calibri" pitchFamily="34" charset="0"/>
              </a:defRPr>
            </a:lvl1pPr>
          </a:lstStyle>
          <a:p>
            <a:pPr>
              <a:defRPr/>
            </a:pPr>
            <a:fld id="{56CD4385-23ED-4FD5-8CBC-080234527345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4240487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467531F-E355-4156-A8A2-0B2CD7AF5DC3}" type="datetimeFigureOut">
              <a:rPr lang="en-US"/>
              <a:pPr>
                <a:defRPr/>
              </a:pPr>
              <a:t>4/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5084412-D501-405E-A437-0CC369550C6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66353CF-8D56-4C66-B110-FA120E4498A7}" type="datetimeFigureOut">
              <a:rPr lang="en-US"/>
              <a:pPr>
                <a:defRPr/>
              </a:pPr>
              <a:t>4/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041588F-4CCC-41C1-BC79-D995E63978B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3C03C02-441B-400B-B38E-306CA98C9AEF}" type="datetimeFigureOut">
              <a:rPr lang="en-US"/>
              <a:pPr>
                <a:defRPr/>
              </a:pPr>
              <a:t>4/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5FDD97A-9BDD-4F9D-ACFB-F5BE1DC8805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DF67B67-D000-428B-8B8F-0DD8EABD1796}" type="datetimeFigureOut">
              <a:rPr lang="en-US"/>
              <a:pPr>
                <a:defRPr/>
              </a:pPr>
              <a:t>4/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D9BCDD8-B050-4D57-A28C-F166298FECE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3439704-34F2-44FA-8534-99AF8653786C}" type="datetimeFigureOut">
              <a:rPr lang="en-US"/>
              <a:pPr>
                <a:defRPr/>
              </a:pPr>
              <a:t>4/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759F13F-F787-4DC9-B120-0E85C66834E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B6388A4-7808-4605-BE90-F83DC2A31C74}" type="datetimeFigureOut">
              <a:rPr lang="en-US"/>
              <a:pPr>
                <a:defRPr/>
              </a:pPr>
              <a:t>4/3/2016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6E3EF73-B1F3-4F95-950A-9AEE9B4394F5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6DCEC3-4B2A-4C3A-B4DE-FCC7428EE685}" type="datetimeFigureOut">
              <a:rPr lang="en-US"/>
              <a:pPr>
                <a:defRPr/>
              </a:pPr>
              <a:t>4/3/2016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6A1038-69B7-4C99-B30C-B4A19018671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846C01D-7FCA-4CA1-A3C5-0EC7C336D316}" type="datetimeFigureOut">
              <a:rPr lang="en-US"/>
              <a:pPr>
                <a:defRPr/>
              </a:pPr>
              <a:t>4/3/2016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F0535CB-15CA-4CC7-8063-0803C3A0553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8A21A6B-C9A4-4038-BA37-11C61DBA807F}" type="datetimeFigureOut">
              <a:rPr lang="en-US"/>
              <a:pPr>
                <a:defRPr/>
              </a:pPr>
              <a:t>4/3/2016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36BF4E-13D5-49F7-AC05-312B43B71CB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F934EC4-FB36-4C75-BB0D-35C78D983375}" type="datetimeFigureOut">
              <a:rPr lang="en-US"/>
              <a:pPr>
                <a:defRPr/>
              </a:pPr>
              <a:t>4/3/2016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2793DD-7649-44E7-87A8-3FD9EDFE745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rtlCol="0">
            <a:normAutofit/>
          </a:bodyPr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pPr lvl="0"/>
            <a:r>
              <a:rPr lang="en-US" noProof="0" smtClean="0"/>
              <a:t>Click icon to add picture</a:t>
            </a:r>
            <a:endParaRPr lang="en-US" noProof="0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DE972E-AF17-4B08-A4BF-27FFAB7E5E0C}" type="datetimeFigureOut">
              <a:rPr lang="en-US"/>
              <a:pPr>
                <a:defRPr/>
              </a:pPr>
              <a:t>4/3/2016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C29A51B-32B4-4990-A302-D1EC3A6C5AF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471488" y="487363"/>
            <a:ext cx="5915025" cy="1766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71488" y="2433638"/>
            <a:ext cx="5915025" cy="58023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663"/>
            <a:ext cx="154305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>
              <a:defRPr/>
            </a:pPr>
            <a:fld id="{8A49DEF2-7D1C-4FD0-B639-030C7BCD74CB}" type="datetimeFigureOut">
              <a:rPr lang="en-US"/>
              <a:pPr>
                <a:defRPr/>
              </a:pPr>
              <a:t>4/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663"/>
            <a:ext cx="2314575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663"/>
            <a:ext cx="1543050" cy="48577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900" smtClean="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38D04887-5513-4305-89F0-F2FBEC157A5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  <a:lvl2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</a:defRPr>
      </a:lvl2pPr>
      <a:lvl3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</a:defRPr>
      </a:lvl3pPr>
      <a:lvl4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</a:defRPr>
      </a:lvl4pPr>
      <a:lvl5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</a:defRPr>
      </a:lvl5pPr>
      <a:lvl6pPr marL="4572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</a:defRPr>
      </a:lvl6pPr>
      <a:lvl7pPr marL="9144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</a:defRPr>
      </a:lvl7pPr>
      <a:lvl8pPr marL="13716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</a:defRPr>
      </a:lvl8pPr>
      <a:lvl9pPr marL="18288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</a:defRPr>
      </a:lvl9pPr>
    </p:titleStyle>
    <p:bodyStyle>
      <a:lvl1pPr marL="171450" indent="-171450" algn="l" defTabSz="685800" rtl="0" eaLnBrk="0" fontAlgn="base" hangingPunct="0">
        <a:lnSpc>
          <a:spcPct val="90000"/>
        </a:lnSpc>
        <a:spcBef>
          <a:spcPts val="750"/>
        </a:spcBef>
        <a:spcAft>
          <a:spcPct val="0"/>
        </a:spcAft>
        <a:buFont typeface="Arial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charset="0"/>
        <a:buChar char="•"/>
        <a:defRPr sz="13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charset="0"/>
        <a:buChar char="•"/>
        <a:defRPr sz="13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image" Target="../media/image2.emf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" name="Group 19"/>
          <p:cNvGrpSpPr/>
          <p:nvPr/>
        </p:nvGrpSpPr>
        <p:grpSpPr>
          <a:xfrm>
            <a:off x="231775" y="160818"/>
            <a:ext cx="6400800" cy="8983182"/>
            <a:chOff x="231775" y="160818"/>
            <a:chExt cx="6400800" cy="8983182"/>
          </a:xfrm>
        </p:grpSpPr>
        <p:sp>
          <p:nvSpPr>
            <p:cNvPr id="15362" name="TextBox 103"/>
            <p:cNvSpPr txBox="1">
              <a:spLocks noChangeArrowheads="1"/>
            </p:cNvSpPr>
            <p:nvPr/>
          </p:nvSpPr>
          <p:spPr bwMode="auto">
            <a:xfrm>
              <a:off x="495300" y="379413"/>
              <a:ext cx="292068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1" hangingPunct="1"/>
              <a:r>
                <a:rPr lang="en-US" sz="800" b="1" dirty="0"/>
                <a:t>A)</a:t>
              </a:r>
            </a:p>
          </p:txBody>
        </p:sp>
        <p:sp>
          <p:nvSpPr>
            <p:cNvPr id="15363" name="TextBox 103"/>
            <p:cNvSpPr txBox="1">
              <a:spLocks noChangeArrowheads="1"/>
            </p:cNvSpPr>
            <p:nvPr/>
          </p:nvSpPr>
          <p:spPr bwMode="auto">
            <a:xfrm>
              <a:off x="3624263" y="406400"/>
              <a:ext cx="292068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1" hangingPunct="1"/>
              <a:r>
                <a:rPr lang="en-US" sz="800" b="1" dirty="0"/>
                <a:t>B)</a:t>
              </a:r>
            </a:p>
          </p:txBody>
        </p:sp>
        <p:sp>
          <p:nvSpPr>
            <p:cNvPr id="15364" name="TextBox 103"/>
            <p:cNvSpPr txBox="1">
              <a:spLocks noChangeArrowheads="1"/>
            </p:cNvSpPr>
            <p:nvPr/>
          </p:nvSpPr>
          <p:spPr bwMode="auto">
            <a:xfrm>
              <a:off x="495300" y="4760913"/>
              <a:ext cx="292068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1" hangingPunct="1"/>
              <a:r>
                <a:rPr lang="en-US" sz="800" b="1" dirty="0"/>
                <a:t>C)</a:t>
              </a:r>
            </a:p>
          </p:txBody>
        </p:sp>
        <p:sp>
          <p:nvSpPr>
            <p:cNvPr id="15365" name="TextBox 103"/>
            <p:cNvSpPr txBox="1">
              <a:spLocks noChangeArrowheads="1"/>
            </p:cNvSpPr>
            <p:nvPr/>
          </p:nvSpPr>
          <p:spPr bwMode="auto">
            <a:xfrm>
              <a:off x="3624263" y="4787900"/>
              <a:ext cx="292068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1" hangingPunct="1"/>
              <a:r>
                <a:rPr lang="en-US" sz="800" b="1"/>
                <a:t>D)</a:t>
              </a:r>
            </a:p>
          </p:txBody>
        </p:sp>
        <p:sp>
          <p:nvSpPr>
            <p:cNvPr id="15366" name="TextBox 96"/>
            <p:cNvSpPr txBox="1">
              <a:spLocks noChangeArrowheads="1"/>
            </p:cNvSpPr>
            <p:nvPr/>
          </p:nvSpPr>
          <p:spPr bwMode="auto">
            <a:xfrm>
              <a:off x="2110806" y="160818"/>
              <a:ext cx="1469155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eaLnBrk="1" hangingPunct="1"/>
              <a:r>
                <a:rPr lang="en-US" sz="800" b="1" dirty="0"/>
                <a:t>Supplementary figure </a:t>
              </a:r>
              <a:r>
                <a:rPr lang="en-US" sz="800" b="1" dirty="0" smtClean="0"/>
                <a:t>6</a:t>
              </a:r>
              <a:endParaRPr lang="en-US" sz="800" b="1" dirty="0"/>
            </a:p>
          </p:txBody>
        </p:sp>
        <p:grpSp>
          <p:nvGrpSpPr>
            <p:cNvPr id="15367" name="Group 24"/>
            <p:cNvGrpSpPr>
              <a:grpSpLocks/>
            </p:cNvGrpSpPr>
            <p:nvPr/>
          </p:nvGrpSpPr>
          <p:grpSpPr bwMode="auto">
            <a:xfrm>
              <a:off x="231775" y="606425"/>
              <a:ext cx="6400800" cy="8537575"/>
              <a:chOff x="231775" y="606425"/>
              <a:chExt cx="6400800" cy="8537575"/>
            </a:xfrm>
          </p:grpSpPr>
          <p:grpSp>
            <p:nvGrpSpPr>
              <p:cNvPr id="15368" name="Group 21"/>
              <p:cNvGrpSpPr>
                <a:grpSpLocks/>
              </p:cNvGrpSpPr>
              <p:nvPr/>
            </p:nvGrpSpPr>
            <p:grpSpPr bwMode="auto">
              <a:xfrm>
                <a:off x="231775" y="606425"/>
                <a:ext cx="6400800" cy="4002088"/>
                <a:chOff x="232229" y="562355"/>
                <a:chExt cx="6400799" cy="4001358"/>
              </a:xfrm>
            </p:grpSpPr>
            <p:graphicFrame>
              <p:nvGraphicFramePr>
                <p:cNvPr id="13" name="Chart 12"/>
                <p:cNvGraphicFramePr/>
                <p:nvPr/>
              </p:nvGraphicFramePr>
              <p:xfrm>
                <a:off x="3607794" y="586593"/>
                <a:ext cx="2223663" cy="2173222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2"/>
                </a:graphicData>
              </a:graphic>
            </p:graphicFrame>
            <p:graphicFrame>
              <p:nvGraphicFramePr>
                <p:cNvPr id="14" name="Chart 13"/>
                <p:cNvGraphicFramePr/>
                <p:nvPr/>
              </p:nvGraphicFramePr>
              <p:xfrm>
                <a:off x="635226" y="562355"/>
                <a:ext cx="2111784" cy="216408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3"/>
                </a:graphicData>
              </a:graphic>
            </p:graphicFrame>
            <p:pic>
              <p:nvPicPr>
                <p:cNvPr id="15377" name="Picture 2"/>
                <p:cNvPicPr>
                  <a:picLocks noChangeAspect="1" noChangeArrowheads="1"/>
                </p:cNvPicPr>
                <p:nvPr/>
              </p:nvPicPr>
              <p:blipFill>
                <a:blip r:embed="rId4"/>
                <a:srcRect l="43867" t="2568" b="51244"/>
                <a:stretch>
                  <a:fillRect/>
                </a:stretch>
              </p:blipFill>
              <p:spPr bwMode="auto">
                <a:xfrm>
                  <a:off x="232229" y="2751683"/>
                  <a:ext cx="3134604" cy="165462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pic>
              <p:nvPicPr>
                <p:cNvPr id="15378" name="Picture 2"/>
                <p:cNvPicPr>
                  <a:picLocks noChangeAspect="1" noChangeArrowheads="1"/>
                </p:cNvPicPr>
                <p:nvPr/>
              </p:nvPicPr>
              <p:blipFill>
                <a:blip r:embed="rId4"/>
                <a:srcRect l="43867" t="47284"/>
                <a:stretch>
                  <a:fillRect/>
                </a:stretch>
              </p:blipFill>
              <p:spPr bwMode="auto">
                <a:xfrm>
                  <a:off x="3532118" y="2695558"/>
                  <a:ext cx="3100910" cy="18681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</p:grpSp>
          <p:grpSp>
            <p:nvGrpSpPr>
              <p:cNvPr id="15369" name="Group 16"/>
              <p:cNvGrpSpPr>
                <a:grpSpLocks/>
              </p:cNvGrpSpPr>
              <p:nvPr/>
            </p:nvGrpSpPr>
            <p:grpSpPr bwMode="auto">
              <a:xfrm>
                <a:off x="522288" y="5000625"/>
                <a:ext cx="5149850" cy="4143375"/>
                <a:chOff x="626495" y="806330"/>
                <a:chExt cx="5148830" cy="4143794"/>
              </a:xfrm>
            </p:grpSpPr>
            <p:graphicFrame>
              <p:nvGraphicFramePr>
                <p:cNvPr id="18" name="Chart 17"/>
                <p:cNvGraphicFramePr/>
                <p:nvPr/>
              </p:nvGraphicFramePr>
              <p:xfrm>
                <a:off x="626495" y="806330"/>
                <a:ext cx="2203450" cy="23114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5"/>
                </a:graphicData>
              </a:graphic>
            </p:graphicFrame>
            <p:graphicFrame>
              <p:nvGraphicFramePr>
                <p:cNvPr id="19" name="Chart 18"/>
                <p:cNvGraphicFramePr/>
                <p:nvPr/>
              </p:nvGraphicFramePr>
              <p:xfrm>
                <a:off x="3806825" y="825500"/>
                <a:ext cx="1968500" cy="23368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6"/>
                </a:graphicData>
              </a:graphic>
            </p:graphicFrame>
            <p:pic>
              <p:nvPicPr>
                <p:cNvPr id="15373" name="Picture 2"/>
                <p:cNvPicPr>
                  <a:picLocks noChangeAspect="1" noChangeArrowheads="1"/>
                </p:cNvPicPr>
                <p:nvPr/>
              </p:nvPicPr>
              <p:blipFill>
                <a:blip r:embed="rId7"/>
                <a:srcRect l="50375" b="45860"/>
                <a:stretch>
                  <a:fillRect/>
                </a:stretch>
              </p:blipFill>
              <p:spPr bwMode="auto">
                <a:xfrm>
                  <a:off x="721985" y="2905424"/>
                  <a:ext cx="2081780" cy="20447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pic>
              <p:nvPicPr>
                <p:cNvPr id="15374" name="Picture 2"/>
                <p:cNvPicPr>
                  <a:picLocks noChangeAspect="1" noChangeArrowheads="1"/>
                </p:cNvPicPr>
                <p:nvPr/>
              </p:nvPicPr>
              <p:blipFill>
                <a:blip r:embed="rId7"/>
                <a:srcRect l="50375" t="55148"/>
                <a:stretch>
                  <a:fillRect/>
                </a:stretch>
              </p:blipFill>
              <p:spPr bwMode="auto">
                <a:xfrm>
                  <a:off x="3252220" y="3000375"/>
                  <a:ext cx="2081780" cy="169386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</p:grpSp>
          <p:sp>
            <p:nvSpPr>
              <p:cNvPr id="24" name="TextBox 23"/>
              <p:cNvSpPr txBox="1"/>
              <p:nvPr/>
            </p:nvSpPr>
            <p:spPr>
              <a:xfrm>
                <a:off x="3695700" y="4052888"/>
                <a:ext cx="1477328" cy="21544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txBody>
              <a:bodyPr wrap="none" lIns="0">
                <a:spAutoFit/>
              </a:bodyPr>
              <a:lstStyle/>
              <a:p>
                <a:pPr>
                  <a:defRPr/>
                </a:pPr>
                <a:r>
                  <a:rPr lang="en-US" sz="800" b="1" dirty="0"/>
                  <a:t>unknown biological process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89907332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0" y="1063347"/>
            <a:ext cx="6858000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 smtClean="0"/>
              <a:t>Supplementary figure S6.</a:t>
            </a:r>
            <a:r>
              <a:rPr lang="en-US" sz="1200" dirty="0" smtClean="0"/>
              <a:t> </a:t>
            </a:r>
            <a:r>
              <a:rPr lang="en-US" sz="1200" b="1" dirty="0" smtClean="0"/>
              <a:t>Functional categorization of transcripts uniquely expressed in DP/PD combined stressed plants. </a:t>
            </a:r>
            <a:r>
              <a:rPr lang="en-US" sz="1200" dirty="0" smtClean="0"/>
              <a:t>DEGs from total </a:t>
            </a:r>
            <a:r>
              <a:rPr lang="en-US" sz="1200" dirty="0" err="1" smtClean="0"/>
              <a:t>transcriptome</a:t>
            </a:r>
            <a:r>
              <a:rPr lang="en-US" sz="1200" dirty="0" smtClean="0"/>
              <a:t> under combined stress and individual stress were compared and unique DEGs under combined stress were identified. Unique DEGs were further classified as up- or down-regulated and were distributed among gene ontology (GO) biological processes (Agilent </a:t>
            </a:r>
            <a:r>
              <a:rPr lang="en-US" sz="1200" dirty="0" err="1" smtClean="0"/>
              <a:t>GeneSpring</a:t>
            </a:r>
            <a:r>
              <a:rPr lang="en-US" sz="1200" dirty="0" smtClean="0"/>
              <a:t> GX12.1.6) in DP </a:t>
            </a:r>
            <a:r>
              <a:rPr lang="en-US" sz="1200" b="1" dirty="0" smtClean="0"/>
              <a:t>(A)</a:t>
            </a:r>
            <a:r>
              <a:rPr lang="en-US" sz="1200" dirty="0" smtClean="0"/>
              <a:t> and PD </a:t>
            </a:r>
            <a:r>
              <a:rPr lang="en-US" sz="1200" b="1" dirty="0" smtClean="0"/>
              <a:t>(B) </a:t>
            </a:r>
            <a:r>
              <a:rPr lang="en-US" sz="1200" dirty="0" smtClean="0"/>
              <a:t>combined stressed plants. GO molecular function based categorization (TAIR GO) is presented for DEGs unique to combined DP stress </a:t>
            </a:r>
            <a:r>
              <a:rPr lang="en-US" sz="1200" b="1" dirty="0" smtClean="0"/>
              <a:t>(C)</a:t>
            </a:r>
            <a:r>
              <a:rPr lang="en-US" sz="1200" dirty="0" smtClean="0"/>
              <a:t> and PD stress </a:t>
            </a:r>
            <a:r>
              <a:rPr lang="en-US" sz="1200" b="1" dirty="0" smtClean="0"/>
              <a:t>(D)</a:t>
            </a:r>
            <a:r>
              <a:rPr lang="en-US" sz="1200" dirty="0" smtClean="0"/>
              <a:t>. Outer and inner ring exhibits up and down-regulated features respectively.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34417478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 Them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 Theme">
    <a:majorFont>
      <a:latin typeface="Calibri Light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 Them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 Them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 Theme">
    <a:majorFont>
      <a:latin typeface="Calibri Light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 Them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3.xml><?xml version="1.0" encoding="utf-8"?>
<a:themeOverride xmlns:a="http://schemas.openxmlformats.org/drawingml/2006/main">
  <a:clrScheme name="Office Them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 Theme">
    <a:majorFont>
      <a:latin typeface="Calibri Light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 Them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4.xml><?xml version="1.0" encoding="utf-8"?>
<a:themeOverride xmlns:a="http://schemas.openxmlformats.org/drawingml/2006/main">
  <a:clrScheme name="Office Them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 Theme">
    <a:majorFont>
      <a:latin typeface="Calibri Light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 Them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7028C09C9D97D24780058C99077D8847" ma:contentTypeVersion="7" ma:contentTypeDescription="Create a new document." ma:contentTypeScope="" ma:versionID="0132886fdf3e2c25019eb3cd8923805d">
  <xsd:schema xmlns:xsd="http://www.w3.org/2001/XMLSchema" xmlns:p="http://schemas.microsoft.com/office/2006/metadata/properties" xmlns:ns2="39616538-2d66-4de6-9e6e-2b8794b75252" targetNamespace="http://schemas.microsoft.com/office/2006/metadata/properties" ma:root="true" ma:fieldsID="afb14a4498c4490eaa362745f3dd1134" ns2:_="">
    <xsd:import namespace="39616538-2d66-4de6-9e6e-2b8794b75252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39616538-2d66-4de6-9e6e-2b8794b75252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DocumentType xmlns="39616538-2d66-4de6-9e6e-2b8794b75252">Presentation</DocumentType>
    <TitleName xmlns="39616538-2d66-4de6-9e6e-2b8794b75252">Presentation 6.PPTX</TitleName>
    <Checked_x0020_Out_x0020_To xmlns="39616538-2d66-4de6-9e6e-2b8794b75252">
      <UserInfo>
        <DisplayName/>
        <AccountId xsi:nil="true"/>
        <AccountType/>
      </UserInfo>
    </Checked_x0020_Out_x0020_To>
    <FileFormat xmlns="39616538-2d66-4de6-9e6e-2b8794b75252">PPTX</FileFormat>
    <DocumentId xmlns="39616538-2d66-4de6-9e6e-2b8794b75252">Presentation 6.PPTX</DocumentId>
    <StageName xmlns="39616538-2d66-4de6-9e6e-2b8794b75252" xsi:nil="true"/>
    <IsDeleted xmlns="39616538-2d66-4de6-9e6e-2b8794b75252">false</IsDeleted>
  </documentManagement>
</p:properties>
</file>

<file path=customXml/itemProps1.xml><?xml version="1.0" encoding="utf-8"?>
<ds:datastoreItem xmlns:ds="http://schemas.openxmlformats.org/officeDocument/2006/customXml" ds:itemID="{A81D7EF1-BCC5-4EDA-943C-CA89F7FFEE2E}"/>
</file>

<file path=customXml/itemProps2.xml><?xml version="1.0" encoding="utf-8"?>
<ds:datastoreItem xmlns:ds="http://schemas.openxmlformats.org/officeDocument/2006/customXml" ds:itemID="{D35489BB-185C-4029-92CA-E410269BC49A}"/>
</file>

<file path=customXml/itemProps3.xml><?xml version="1.0" encoding="utf-8"?>
<ds:datastoreItem xmlns:ds="http://schemas.openxmlformats.org/officeDocument/2006/customXml" ds:itemID="{0D8CDDD3-B67E-4162-A3E7-D5775F091521}"/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124</TotalTime>
  <Words>228</Words>
  <Application>Microsoft Office PowerPoint</Application>
  <PresentationFormat>On-screen Show (4:3)</PresentationFormat>
  <Paragraphs>107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ser</dc:creator>
  <cp:lastModifiedBy>Senthil K Muthappa</cp:lastModifiedBy>
  <cp:revision>137</cp:revision>
  <cp:lastPrinted>2016-01-06T07:15:43Z</cp:lastPrinted>
  <dcterms:created xsi:type="dcterms:W3CDTF">2015-12-21T05:37:17Z</dcterms:created>
  <dcterms:modified xsi:type="dcterms:W3CDTF">2016-04-03T07:41:5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7028C09C9D97D24780058C99077D8847</vt:lpwstr>
  </property>
</Properties>
</file>